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06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0461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488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279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779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100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22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0451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284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178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57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F6FF8-663D-411A-8F42-FA168E138E36}" type="datetimeFigureOut">
              <a:rPr lang="zh-CN" altLang="en-US" smtClean="0"/>
              <a:t>2015/6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EA246-67D8-4B08-93A8-53A131AD88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9118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/>
          <p:cNvSpPr txBox="1">
            <a:spLocks noChangeArrowheads="1"/>
          </p:cNvSpPr>
          <p:nvPr/>
        </p:nvSpPr>
        <p:spPr bwMode="auto">
          <a:xfrm>
            <a:off x="358775" y="420688"/>
            <a:ext cx="93630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panose="05000000000000000000" pitchFamily="2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panose="05000000000000000000" pitchFamily="2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panose="05000000000000000000" pitchFamily="2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panose="05000000000000000000" pitchFamily="2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anose="02020603050405020304" pitchFamily="18" charset="0"/>
                <a:ea typeface="msgothic" charset="0"/>
                <a:cs typeface="msgothic" charset="0"/>
              </a:defRPr>
            </a:lvl9pPr>
          </a:lstStyle>
          <a:p>
            <a:pPr algn="ctr"/>
            <a:r>
              <a:rPr lang="en-GB" altLang="zh-CN" sz="1600" b="1" dirty="0">
                <a:latin typeface="Arial" panose="020B0604020202020204" pitchFamily="34" charset="0"/>
              </a:rPr>
              <a:t>Specific primers used for amplification of the target alleles of </a:t>
            </a:r>
            <a:r>
              <a:rPr lang="en-GB" altLang="zh-CN" sz="1600" b="1" dirty="0" err="1" smtClean="0">
                <a:latin typeface="Arial" panose="020B0604020202020204" pitchFamily="34" charset="0"/>
              </a:rPr>
              <a:t>Klebsiella</a:t>
            </a:r>
            <a:r>
              <a:rPr lang="en-GB" altLang="zh-CN" sz="1600" b="1" dirty="0" smtClean="0">
                <a:latin typeface="Arial" panose="020B0604020202020204" pitchFamily="34" charset="0"/>
              </a:rPr>
              <a:t> </a:t>
            </a:r>
            <a:r>
              <a:rPr lang="en-GB" altLang="zh-CN" sz="1600" b="1" dirty="0" err="1">
                <a:latin typeface="Arial" panose="020B0604020202020204" pitchFamily="34" charset="0"/>
              </a:rPr>
              <a:t>pneumoniae</a:t>
            </a:r>
            <a:r>
              <a:rPr lang="en-GB" altLang="zh-CN" sz="1600" b="1" dirty="0">
                <a:latin typeface="Arial" panose="020B0604020202020204" pitchFamily="34" charset="0"/>
              </a:rPr>
              <a:t>.</a:t>
            </a:r>
          </a:p>
        </p:txBody>
      </p:sp>
      <p:graphicFrame>
        <p:nvGraphicFramePr>
          <p:cNvPr id="8" name="表格 7"/>
          <p:cNvGraphicFramePr>
            <a:graphicFrameLocks noGrp="1"/>
          </p:cNvGraphicFramePr>
          <p:nvPr>
            <p:extLst/>
          </p:nvPr>
        </p:nvGraphicFramePr>
        <p:xfrm>
          <a:off x="0" y="420688"/>
          <a:ext cx="12240883" cy="7500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45720"/>
                <a:gridCol w="3597216"/>
                <a:gridCol w="5400135"/>
                <a:gridCol w="1897812"/>
              </a:tblGrid>
              <a:tr h="27728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 Gene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 </a:t>
                      </a: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 Reactions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s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46191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1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TAGGTATTGCAAGCCATGC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CCCAGGTTAATGAATCCGT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5 min, followed by 40 cycles of 96℃ 1 min, 56℃ 15s, and 74℃ 1 min, and 72℃ 10 min. </a:t>
                      </a:r>
                      <a:endParaRPr lang="zh-CN" altLang="zh-CN" sz="1600" b="1" kern="100" dirty="0" smtClean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400" b="1" u="none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 Infect Dis. 2007 Aug 1;45(3):284-93.</a:t>
                      </a:r>
                      <a:endParaRPr lang="zh-CN" sz="1400" b="1" u="none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58932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2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GAGCCATTTGAATTCGGTG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CCCTAGCACTGGCTTAAGT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5 min, followed by 40 cycles of 96℃ 1 min, 56℃ 15s, and 74℃ 1 min, and 72℃ 10 min.</a:t>
                      </a: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400" b="1" u="none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 Infect Dis. 2007 Aug 1;45(3):284-93.</a:t>
                      </a:r>
                      <a:endParaRPr lang="zh-CN" sz="1400" b="1" u="none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6668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2S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AACCATGGTGGTCGATTAG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GGTAGCCATATCCCTTTGG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5 min, followed by 40 cycles of 96℃ 1 min, 56℃ 15s, and 74℃ 1 min, and 72℃ 10 min.</a:t>
                      </a: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400" b="1" u="none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 Infect Dis. 2007 Apr 15;195(8):1235-6</a:t>
                      </a:r>
                      <a:endParaRPr lang="zh-CN" sz="1400" b="1" u="none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25447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erobactin1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CATAGGCGGATACGAACAT-3’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ACAGGGCAATTGCTTACCT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</a:t>
                      </a:r>
                      <a:r>
                        <a:rPr lang="en-US" altLang="zh-CN" sz="1600" b="1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, followed by 40 cycles of 95℃ 1 min, 50℃ 1</a:t>
                      </a:r>
                      <a:r>
                        <a:rPr lang="en-US" altLang="zh-CN" sz="1600" b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nd 72℃ 2 min, and 72℃ 7 min.</a:t>
                      </a:r>
                      <a:endParaRPr lang="zh-CN" altLang="zh-CN" sz="1600" b="1" kern="100" dirty="0" smtClean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u="none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agn </a:t>
                      </a:r>
                      <a:r>
                        <a:rPr lang="en-US" altLang="zh-CN" sz="1400" b="1" u="none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icrobiol</a:t>
                      </a:r>
                      <a:r>
                        <a:rPr lang="en-US" altLang="zh-CN" sz="1400" b="1" u="none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Infect Dis. 2008 Sep;62(1):1-6</a:t>
                      </a:r>
                    </a:p>
                  </a:txBody>
                  <a:tcPr marL="50544" marR="50544" marT="25272" marB="25272"/>
                </a:tc>
              </a:tr>
              <a:tr h="25447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erobactin2</a:t>
                      </a:r>
                      <a:endParaRPr lang="zh-CN" sz="1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TGTCGGCATCGGTTTTATT-3’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TGGCGTGTCGATTATTACCA-3’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</a:t>
                      </a:r>
                      <a:r>
                        <a:rPr lang="en-US" altLang="zh-CN" sz="1600" b="1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, followed by 40 cycles of 95℃ 1 min, 50℃ 1</a:t>
                      </a:r>
                      <a:r>
                        <a:rPr lang="en-US" altLang="zh-CN" sz="1600" b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nd 72℃ 2 min, and 72℃ 7 min.</a:t>
                      </a:r>
                      <a:endParaRPr lang="zh-CN" altLang="zh-CN" sz="1600" b="1" kern="100" dirty="0" smtClean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u="none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agn </a:t>
                      </a:r>
                      <a:r>
                        <a:rPr lang="en-US" altLang="zh-CN" sz="1400" b="1" u="none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icrobiol</a:t>
                      </a:r>
                      <a:r>
                        <a:rPr lang="en-US" altLang="zh-CN" sz="1400" b="1" u="none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Infect Dis. 2008 Sep;62(1):1-6</a:t>
                      </a:r>
                    </a:p>
                  </a:txBody>
                  <a:tcPr marL="50544" marR="50544" marT="25272" marB="25272"/>
                </a:tc>
              </a:tr>
              <a:tr h="25658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s</a:t>
                      </a:r>
                      <a:endParaRPr lang="zh-CN" sz="1800" b="1" i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CGAAACATTACGCACCTTT-3’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TCACGAAGAGCCAGGTCAC-3’</a:t>
                      </a: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altLang="zh-CN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</a:t>
                      </a:r>
                      <a:r>
                        <a:rPr lang="en-US" altLang="zh-CN" sz="1800" b="1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, followed by 40 cycles of 95℃ 1 min, 50℃ 1</a:t>
                      </a:r>
                      <a:r>
                        <a:rPr lang="en-US" altLang="zh-CN" sz="1800" b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</a:t>
                      </a:r>
                      <a:r>
                        <a:rPr lang="en-US" altLang="zh-CN" sz="18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nd 72℃ 2 min, and 72℃ 7 min.</a:t>
                      </a: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altLang="zh-CN" sz="1400" b="1" u="none" kern="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agn Microbiol Infect Dis 2008, 62(1):1-6</a:t>
                      </a:r>
                      <a:endParaRPr lang="zh-CN" sz="1400" b="1" u="none" kern="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25658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u</a:t>
                      </a:r>
                      <a:endParaRPr lang="zh-CN" sz="1800" b="1" i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TAGTAGGCGAGCACCGAGA-3’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GAACCTTCCTCGCTGAACA-3’</a:t>
                      </a:r>
                      <a:r>
                        <a:rPr lang="en-US" sz="16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</a:t>
                      </a:r>
                      <a:r>
                        <a:rPr lang="en-US" altLang="zh-CN" sz="1600" b="1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, followed by 40 cycles of 95℃ 1 min, 50℃ 1</a:t>
                      </a:r>
                      <a:r>
                        <a:rPr lang="en-US" altLang="zh-CN" sz="1600" b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n</a:t>
                      </a: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nd 72℃ 2 min, and 72℃ 7 min.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endParaRPr lang="zh-CN" sz="16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altLang="zh-CN" sz="1400" b="1" u="none" kern="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agn Microbiol Infect Dis 2008, 62(1):1-6</a:t>
                      </a:r>
                      <a:endParaRPr lang="zh-CN" sz="1400" b="1" u="none" kern="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6668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A</a:t>
                      </a:r>
                      <a:endParaRPr lang="zh-CN" sz="1800" b="1" i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CAATGGCCATTTGCGTTAG-3’</a:t>
                      </a:r>
                      <a:endParaRPr lang="zh-CN" sz="1600" b="1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GGTGCTCTTTACATCATTGC-3’</a:t>
                      </a:r>
                      <a:endParaRPr lang="zh-CN" sz="16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5 min, followed by 40 cycles of 95 ℃ 1 min, 50℃ 1 min, and 72℃ 2 min, and 72℃ 7 min.</a:t>
                      </a:r>
                      <a:endParaRPr lang="zh-CN" sz="16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14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 Clin Microbiol. 2007 Feb; 45(2): 466–471.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  <a:tr h="6668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kern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pA</a:t>
                      </a:r>
                      <a:endParaRPr lang="zh-CN" sz="1800" b="1" i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ACTGGGCTACCTCTGCTTCA-3’</a:t>
                      </a:r>
                      <a:endParaRPr lang="zh-CN" sz="1600" b="1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600" b="1" ker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-CTTGCATGAGCCATCTTTCA-3’</a:t>
                      </a:r>
                      <a:endParaRPr lang="zh-CN" sz="16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600" b="1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℃ 5 min, followed by 40 cycles of 95 ℃ 1 min, 50℃ 1 min, and 72℃ 2 min, and 72℃ 7 min.</a:t>
                      </a:r>
                      <a:endParaRPr lang="zh-CN" altLang="zh-CN" sz="1600" b="1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it-IT" sz="1400" b="1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 Clin Microbiol. 2007 Feb; 45(2): 466–471.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544" marR="50544" marT="25272" marB="25272"/>
                </a:tc>
              </a:tr>
            </a:tbl>
          </a:graphicData>
        </a:graphic>
      </p:graphicFrame>
      <p:sp>
        <p:nvSpPr>
          <p:cNvPr id="5" name="文本框 1"/>
          <p:cNvSpPr txBox="1"/>
          <p:nvPr/>
        </p:nvSpPr>
        <p:spPr>
          <a:xfrm>
            <a:off x="-131882" y="-197221"/>
            <a:ext cx="1252637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Table 1: </a:t>
            </a:r>
            <a:r>
              <a:rPr lang="en-GB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pecific primers </a:t>
            </a:r>
            <a:r>
              <a:rPr lang="en-GB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for </a:t>
            </a:r>
            <a:r>
              <a:rPr lang="en-GB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identifying</a:t>
            </a:r>
            <a:r>
              <a:rPr lang="en-GB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GB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key Virulence factors </a:t>
            </a:r>
            <a:r>
              <a:rPr lang="en-GB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or capsule </a:t>
            </a:r>
            <a:r>
              <a:rPr lang="en-GB" b="1" kern="1200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erovars</a:t>
            </a:r>
            <a:r>
              <a:rPr lang="en-GB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of </a:t>
            </a:r>
            <a:r>
              <a:rPr lang="en-GB" b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hvKP</a:t>
            </a:r>
            <a:r>
              <a:rPr lang="en-GB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GB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trains in this study</a:t>
            </a:r>
            <a:r>
              <a:rPr lang="en-GB" sz="36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endParaRPr lang="zh-CN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 algn="just">
              <a:spcAft>
                <a:spcPts val="0"/>
              </a:spcAft>
            </a:pPr>
            <a:r>
              <a:rPr lang="en-US" sz="1400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905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92DD200099084EAEF242F13933C48E" ma:contentTypeVersion="7" ma:contentTypeDescription="Create a new document." ma:contentTypeScope="" ma:versionID="2d913875ce4670ef9b7de9581d354d6a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1.PPTX</TitleName>
    <DocumentType xmlns="018c3ce0-25d7-4964-8f5f-0766fc370baa">Presentation</DocumentType>
    <DocumentId xmlns="018c3ce0-25d7-4964-8f5f-0766fc370baa">Presentation 1.PPTX</DocumentId>
    <FileFormat xmlns="018c3ce0-25d7-4964-8f5f-0766fc370baa">PPTX</FileFormat>
    <StageName xmlns="018c3ce0-25d7-4964-8f5f-0766fc370baa" xsi:nil="true"/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4747616B-AD8F-4089-9A09-35A1F4E4ECFD}"/>
</file>

<file path=customXml/itemProps2.xml><?xml version="1.0" encoding="utf-8"?>
<ds:datastoreItem xmlns:ds="http://schemas.openxmlformats.org/officeDocument/2006/customXml" ds:itemID="{00186187-BF42-4986-B3CF-90E499CD2F1F}"/>
</file>

<file path=customXml/itemProps3.xml><?xml version="1.0" encoding="utf-8"?>
<ds:datastoreItem xmlns:ds="http://schemas.openxmlformats.org/officeDocument/2006/customXml" ds:itemID="{C7D5D85B-24A2-47C1-A4D9-C515BB1145FF}"/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26</Words>
  <Application>Microsoft Office PowerPoint</Application>
  <PresentationFormat>宽屏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msgothic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zhu</dc:creator>
  <cp:lastModifiedBy>zhuzhu</cp:lastModifiedBy>
  <cp:revision>3</cp:revision>
  <dcterms:created xsi:type="dcterms:W3CDTF">2015-06-02T20:27:06Z</dcterms:created>
  <dcterms:modified xsi:type="dcterms:W3CDTF">2015-06-03T02:4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E92DD200099084EAEF242F13933C48E</vt:lpwstr>
  </property>
</Properties>
</file>